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10375" cy="9942513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11"/>
    <p:restoredTop sz="94694"/>
  </p:normalViewPr>
  <p:slideViewPr>
    <p:cSldViewPr snapToGrid="0">
      <p:cViewPr varScale="1">
        <p:scale>
          <a:sx n="108" d="100"/>
          <a:sy n="108" d="100"/>
        </p:scale>
        <p:origin x="67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7625" y="0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41FFE1-2FDA-D44A-9144-013A70DE8463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3013"/>
            <a:ext cx="5965825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1038" y="4784725"/>
            <a:ext cx="5448300" cy="3914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4038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7625" y="9444038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AE29D4-F9C0-754F-8C8A-DA8D84AF5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1061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AB12DC-04FB-60F1-87C5-B0F1A39728A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A7AA82C-E27D-F26B-F116-D20E5CC604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pl-P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3288AF-F1CA-A446-51EF-CDDF35DA6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5B97FB-2179-7EA6-2790-3A76CC6914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69AB59-B0F6-631C-158B-C7566C944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14123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B24BBD-15BF-3F14-705E-C9CA9B00B6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CE59C1-6D98-1C1D-423B-C2E7E96EEE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444D5F-A7C8-20D8-4DD6-5004576FF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8D78D9-163E-CFE0-6F71-1B4106199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2224D8-C6D6-A2D9-09BF-5F4C3A173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184335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E7596B5-A36E-9DF7-6C0A-B6BEA224BD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6D1A1A-BE09-5A92-3D09-607AEBB2CC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61C659-CF5E-AC42-1A2F-0705FE9860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76B3C1-0F70-6809-B79E-7C4642260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144725-EA0C-BA46-2ED6-542B8928C4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392493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419796-766E-E8D4-5BF5-3F9CE904CE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EFC875-0BAC-715C-90C6-8D809AFAF3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0DBE9E-F48D-D142-5DB2-5BF71CE35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A44FC9-43A0-1BC9-93E2-249B929F44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24B3AE-02DF-C699-A2FF-FD57A24469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827888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C05AAB-CF5D-72B6-8B39-C0F066A61C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EFD1A7-9ED6-F018-6AA1-5ED936B3B4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161147-A1FE-DE69-3A9C-C263C0FCC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E9298A-98FE-6AAC-9329-C126D7317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4AE61D-F251-2F0C-8807-43FE862F9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56122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D8F750-BBF6-BBB2-E08F-B3960BA0AD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2F4BD1-AA20-2D89-7F7B-8FCDB19FA6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93CF8B-615B-7FC2-E9A1-1906790B83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743F63-D557-D2A1-D96C-C88F0D7AB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01455B-60CF-E988-442F-37C1C5495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0E5D8B-3F84-C645-BF45-9A5FAE731C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25825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CD23CC-7FFC-A5F2-3529-C79B3BAFF6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A79239-37F3-C5BE-E96C-D0171726D4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2C8752-D49A-CCAA-4C89-F30B6F3D19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2910571-4409-D942-E483-5359AE93A7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FD7832-BAE9-15C8-AA69-0BC49A143C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9C46DD8-52AC-9436-7406-CD07F674B3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2B9416-B262-57E0-7BEF-8E13A0782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327C64D-0DFB-F472-7435-620C20B332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89304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CAC312-7E80-3DC1-4A90-FCA7D55727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A1991A1-B568-B402-2955-6D56E302CE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1C676B7-B32C-0644-3151-BF642A596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D579172-C3A1-15A9-53CD-FB0E807A89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56316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4B4B527-FAFB-3381-AD78-C2B622AB74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1D0DCB6-2D9C-7D3F-671E-2458455D57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4E9AD7-09B2-EE48-809F-A374557E5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0533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527562-A819-8B5D-947A-B3EA2AEC77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812EC8-8464-F59E-AAB5-F2C1F7C852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722CDF-CD75-D1F3-766B-44A9E9F239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7AA520-76CD-5C26-944D-96D7502BFD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C74ECD-8BBF-70D9-4755-31F7A65D29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2A2216-7C3F-B511-11D5-A6C5C7A272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47636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46B37D-514E-2E93-039B-F096EA9606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907B12D-4B19-09E5-DB4E-A6A78C4ED0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A49FC2-C521-E47F-CF65-362641A752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78021B-06DE-BCA1-2606-114A2D51BF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D5F49D-4A91-6235-BB89-EB23F229D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CFB664-A348-5D15-FEAB-5135506F3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54631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E6596E-1415-0810-179E-F5DDA04EFF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141AB2-4287-EA08-F8DB-7DCE2F286A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11E1A7-AD13-0257-F6B6-0834B0C508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23E4D9-F2B3-DCA2-1662-311E14D4F8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FC18CA-9151-F835-59A5-97A97FD2D5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414079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png"/><Relationship Id="rId3" Type="http://schemas.openxmlformats.org/officeDocument/2006/relationships/image" Target="../media/image2.em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tiff"/><Relationship Id="rId5" Type="http://schemas.openxmlformats.org/officeDocument/2006/relationships/image" Target="../media/image4.emf"/><Relationship Id="rId10" Type="http://schemas.openxmlformats.org/officeDocument/2006/relationships/image" Target="../media/image9.tiff"/><Relationship Id="rId4" Type="http://schemas.openxmlformats.org/officeDocument/2006/relationships/image" Target="../media/image3.emf"/><Relationship Id="rId9" Type="http://schemas.openxmlformats.org/officeDocument/2006/relationships/image" Target="../media/image8.tiff"/><Relationship Id="rId1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>
            <a:extLst>
              <a:ext uri="{FF2B5EF4-FFF2-40B4-BE49-F238E27FC236}">
                <a16:creationId xmlns:a16="http://schemas.microsoft.com/office/drawing/2014/main" id="{97E0D154-8541-E911-DD05-182E71EF2CF3}"/>
              </a:ext>
            </a:extLst>
          </p:cNvPr>
          <p:cNvSpPr txBox="1"/>
          <p:nvPr/>
        </p:nvSpPr>
        <p:spPr>
          <a:xfrm>
            <a:off x="9762234" y="6474594"/>
            <a:ext cx="25014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4</a:t>
            </a:r>
          </a:p>
        </p:txBody>
      </p:sp>
      <p:grpSp>
        <p:nvGrpSpPr>
          <p:cNvPr id="51" name="Group 50">
            <a:extLst>
              <a:ext uri="{FF2B5EF4-FFF2-40B4-BE49-F238E27FC236}">
                <a16:creationId xmlns:a16="http://schemas.microsoft.com/office/drawing/2014/main" id="{AD7E6C57-EEE0-EFD6-C38F-6324070E4632}"/>
              </a:ext>
            </a:extLst>
          </p:cNvPr>
          <p:cNvGrpSpPr/>
          <p:nvPr/>
        </p:nvGrpSpPr>
        <p:grpSpPr>
          <a:xfrm>
            <a:off x="129375" y="446541"/>
            <a:ext cx="5130299" cy="5849141"/>
            <a:chOff x="129375" y="446541"/>
            <a:chExt cx="5130299" cy="5849141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7F5B538F-C00E-4240-8614-9005A54424D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22314" y="771408"/>
              <a:ext cx="1737360" cy="262034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8" name="TextBox 47">
              <a:extLst>
                <a:ext uri="{FF2B5EF4-FFF2-40B4-BE49-F238E27FC236}">
                  <a16:creationId xmlns:a16="http://schemas.microsoft.com/office/drawing/2014/main" id="{414834D3-88FD-6DD7-7428-A69728CA4377}"/>
                </a:ext>
              </a:extLst>
            </p:cNvPr>
            <p:cNvSpPr txBox="1"/>
            <p:nvPr/>
          </p:nvSpPr>
          <p:spPr>
            <a:xfrm>
              <a:off x="129814" y="446541"/>
              <a:ext cx="34015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2000" b="1" dirty="0"/>
                <a:t>A</a:t>
              </a:r>
            </a:p>
          </p:txBody>
        </p:sp>
        <p:grpSp>
          <p:nvGrpSpPr>
            <p:cNvPr id="40" name="Grupa 39">
              <a:extLst>
                <a:ext uri="{FF2B5EF4-FFF2-40B4-BE49-F238E27FC236}">
                  <a16:creationId xmlns:a16="http://schemas.microsoft.com/office/drawing/2014/main" id="{EDB83D1B-08D9-B406-4FAC-693A8FDB3E9A}"/>
                </a:ext>
              </a:extLst>
            </p:cNvPr>
            <p:cNvGrpSpPr/>
            <p:nvPr/>
          </p:nvGrpSpPr>
          <p:grpSpPr>
            <a:xfrm>
              <a:off x="324330" y="734090"/>
              <a:ext cx="1737360" cy="2631995"/>
              <a:chOff x="324330" y="734090"/>
              <a:chExt cx="1737360" cy="2631995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2DAA0BBD-4D92-704C-BAF8-78AB0907D6E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4330" y="745738"/>
                <a:ext cx="1737360" cy="262034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9" name="TextBox 28">
                <a:extLst>
                  <a:ext uri="{FF2B5EF4-FFF2-40B4-BE49-F238E27FC236}">
                    <a16:creationId xmlns:a16="http://schemas.microsoft.com/office/drawing/2014/main" id="{ABE4F6C0-D47B-9F17-1EE7-9C2C3900A0C8}"/>
                  </a:ext>
                </a:extLst>
              </p:cNvPr>
              <p:cNvSpPr txBox="1"/>
              <p:nvPr/>
            </p:nvSpPr>
            <p:spPr>
              <a:xfrm>
                <a:off x="1157566" y="734090"/>
                <a:ext cx="740228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l-PL" sz="1400" i="1" dirty="0"/>
                  <a:t>Nlrp3</a:t>
                </a:r>
                <a:r>
                  <a:rPr lang="en-US" sz="1400" i="1" dirty="0"/>
                  <a:t>                              </a:t>
                </a:r>
              </a:p>
            </p:txBody>
          </p:sp>
        </p:grpSp>
        <p:grpSp>
          <p:nvGrpSpPr>
            <p:cNvPr id="42" name="Grupa 41">
              <a:extLst>
                <a:ext uri="{FF2B5EF4-FFF2-40B4-BE49-F238E27FC236}">
                  <a16:creationId xmlns:a16="http://schemas.microsoft.com/office/drawing/2014/main" id="{B874DEE4-29E5-014B-5743-7564DBEE24C2}"/>
                </a:ext>
              </a:extLst>
            </p:cNvPr>
            <p:cNvGrpSpPr/>
            <p:nvPr/>
          </p:nvGrpSpPr>
          <p:grpSpPr>
            <a:xfrm>
              <a:off x="1784954" y="764592"/>
              <a:ext cx="1737360" cy="2579629"/>
              <a:chOff x="1784954" y="764592"/>
              <a:chExt cx="1737360" cy="2579629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207F2C2A-4725-8548-9DC3-27112055DDC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84954" y="818943"/>
                <a:ext cx="1737360" cy="252527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1" name="TextBox 29">
                <a:extLst>
                  <a:ext uri="{FF2B5EF4-FFF2-40B4-BE49-F238E27FC236}">
                    <a16:creationId xmlns:a16="http://schemas.microsoft.com/office/drawing/2014/main" id="{6FC60D15-ADF6-7E8A-1E35-C8F84EF725EC}"/>
                  </a:ext>
                </a:extLst>
              </p:cNvPr>
              <p:cNvSpPr txBox="1"/>
              <p:nvPr/>
            </p:nvSpPr>
            <p:spPr>
              <a:xfrm>
                <a:off x="2551487" y="764592"/>
                <a:ext cx="740228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i="1" dirty="0"/>
                  <a:t>IL-1</a:t>
                </a:r>
                <a:r>
                  <a:rPr lang="en-US" sz="1400" i="1" dirty="0">
                    <a:latin typeface="Symbol" pitchFamily="2" charset="2"/>
                  </a:rPr>
                  <a:t>b</a:t>
                </a:r>
                <a:r>
                  <a:rPr lang="en-US" sz="1400" i="1" dirty="0"/>
                  <a:t>                              </a:t>
                </a:r>
              </a:p>
            </p:txBody>
          </p:sp>
        </p:grpSp>
        <p:sp>
          <p:nvSpPr>
            <p:cNvPr id="43" name="TextBox 30">
              <a:extLst>
                <a:ext uri="{FF2B5EF4-FFF2-40B4-BE49-F238E27FC236}">
                  <a16:creationId xmlns:a16="http://schemas.microsoft.com/office/drawing/2014/main" id="{CA24AADE-659B-5C35-ECAE-7A0D2147CFDF}"/>
                </a:ext>
              </a:extLst>
            </p:cNvPr>
            <p:cNvSpPr txBox="1"/>
            <p:nvPr/>
          </p:nvSpPr>
          <p:spPr>
            <a:xfrm>
              <a:off x="4192652" y="771408"/>
              <a:ext cx="74022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i="1" dirty="0"/>
                <a:t>  </a:t>
              </a:r>
              <a:r>
                <a:rPr lang="pl-PL" sz="1400" i="1" dirty="0"/>
                <a:t>IL-18</a:t>
              </a:r>
              <a:endParaRPr lang="en-US" sz="1400" i="1" dirty="0"/>
            </a:p>
          </p:txBody>
        </p:sp>
        <p:grpSp>
          <p:nvGrpSpPr>
            <p:cNvPr id="47" name="Grupa 46">
              <a:extLst>
                <a:ext uri="{FF2B5EF4-FFF2-40B4-BE49-F238E27FC236}">
                  <a16:creationId xmlns:a16="http://schemas.microsoft.com/office/drawing/2014/main" id="{6A93FB3C-A3AD-82B4-AF3D-8337ECFCA1B5}"/>
                </a:ext>
              </a:extLst>
            </p:cNvPr>
            <p:cNvGrpSpPr/>
            <p:nvPr/>
          </p:nvGrpSpPr>
          <p:grpSpPr>
            <a:xfrm>
              <a:off x="942866" y="3675335"/>
              <a:ext cx="1737360" cy="2620347"/>
              <a:chOff x="942866" y="3675335"/>
              <a:chExt cx="1737360" cy="2620347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ECDE2161-9B2C-D647-A952-8503C6C8BD61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42866" y="3675335"/>
                <a:ext cx="1737360" cy="262034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4" name="TextBox 6">
                <a:extLst>
                  <a:ext uri="{FF2B5EF4-FFF2-40B4-BE49-F238E27FC236}">
                    <a16:creationId xmlns:a16="http://schemas.microsoft.com/office/drawing/2014/main" id="{5E03B594-45EA-B20C-3D99-B3169F45075E}"/>
                  </a:ext>
                </a:extLst>
              </p:cNvPr>
              <p:cNvSpPr txBox="1"/>
              <p:nvPr/>
            </p:nvSpPr>
            <p:spPr>
              <a:xfrm>
                <a:off x="1628939" y="3697199"/>
                <a:ext cx="740228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i="1" dirty="0"/>
                  <a:t>SDF-1                               </a:t>
                </a:r>
              </a:p>
            </p:txBody>
          </p:sp>
        </p:grpSp>
        <p:grpSp>
          <p:nvGrpSpPr>
            <p:cNvPr id="46" name="Grupa 45">
              <a:extLst>
                <a:ext uri="{FF2B5EF4-FFF2-40B4-BE49-F238E27FC236}">
                  <a16:creationId xmlns:a16="http://schemas.microsoft.com/office/drawing/2014/main" id="{40A31936-1BEB-6993-6F80-190B63186C94}"/>
                </a:ext>
              </a:extLst>
            </p:cNvPr>
            <p:cNvGrpSpPr/>
            <p:nvPr/>
          </p:nvGrpSpPr>
          <p:grpSpPr>
            <a:xfrm>
              <a:off x="2725529" y="3627800"/>
              <a:ext cx="1737360" cy="2620347"/>
              <a:chOff x="2725529" y="3627800"/>
              <a:chExt cx="1737360" cy="2620347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302160E3-0B66-2643-874C-7E8D3A88DB3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725529" y="3627800"/>
                <a:ext cx="1737360" cy="262034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5" name="TextBox 27">
                <a:extLst>
                  <a:ext uri="{FF2B5EF4-FFF2-40B4-BE49-F238E27FC236}">
                    <a16:creationId xmlns:a16="http://schemas.microsoft.com/office/drawing/2014/main" id="{B78B9BBE-5BDE-0F98-7C74-0028E6ECB858}"/>
                  </a:ext>
                </a:extLst>
              </p:cNvPr>
              <p:cNvSpPr txBox="1"/>
              <p:nvPr/>
            </p:nvSpPr>
            <p:spPr>
              <a:xfrm>
                <a:off x="3389235" y="3643102"/>
                <a:ext cx="740228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i="1" dirty="0"/>
                  <a:t>CXCR4</a:t>
                </a:r>
              </a:p>
            </p:txBody>
          </p:sp>
        </p:grp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B13CBA57-C277-203D-6688-24D1E439C58D}"/>
                </a:ext>
              </a:extLst>
            </p:cNvPr>
            <p:cNvSpPr/>
            <p:nvPr/>
          </p:nvSpPr>
          <p:spPr>
            <a:xfrm>
              <a:off x="129375" y="471696"/>
              <a:ext cx="4960419" cy="582398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013059D9-7979-ACC2-BC68-CA46A3324F3C}"/>
              </a:ext>
            </a:extLst>
          </p:cNvPr>
          <p:cNvGrpSpPr/>
          <p:nvPr/>
        </p:nvGrpSpPr>
        <p:grpSpPr>
          <a:xfrm>
            <a:off x="5144266" y="433521"/>
            <a:ext cx="7058293" cy="5862161"/>
            <a:chOff x="5144266" y="433521"/>
            <a:chExt cx="7058293" cy="5862161"/>
          </a:xfrm>
        </p:grpSpPr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9643D319-342F-41F8-0B95-6F22A339B66C}"/>
                </a:ext>
              </a:extLst>
            </p:cNvPr>
            <p:cNvGrpSpPr/>
            <p:nvPr/>
          </p:nvGrpSpPr>
          <p:grpSpPr>
            <a:xfrm>
              <a:off x="5328455" y="745738"/>
              <a:ext cx="6874104" cy="4641368"/>
              <a:chOff x="5839385" y="-381000"/>
              <a:chExt cx="6874104" cy="4641368"/>
            </a:xfrm>
          </p:grpSpPr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FEDFD521-2A7F-0E1D-99BE-98FF011A111A}"/>
                  </a:ext>
                </a:extLst>
              </p:cNvPr>
              <p:cNvGrpSpPr/>
              <p:nvPr/>
            </p:nvGrpSpPr>
            <p:grpSpPr>
              <a:xfrm>
                <a:off x="5839385" y="-323851"/>
                <a:ext cx="6858000" cy="4343400"/>
                <a:chOff x="-18288" y="522514"/>
                <a:chExt cx="9144000" cy="5791200"/>
              </a:xfrm>
            </p:grpSpPr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57209017-F59B-63FB-5F59-A5152495B1E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0" y="968831"/>
                  <a:ext cx="2286000" cy="2286000"/>
                </a:xfrm>
                <a:prstGeom prst="rect">
                  <a:avLst/>
                </a:prstGeom>
              </p:spPr>
            </p:pic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5B2B5972-8828-C55E-8D66-53FCBAC23DF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286000" y="968831"/>
                  <a:ext cx="2286000" cy="2286000"/>
                </a:xfrm>
                <a:prstGeom prst="rect">
                  <a:avLst/>
                </a:prstGeom>
              </p:spPr>
            </p:pic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2E30F0CA-BF38-88A8-28EE-A86372FD9F6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9294" y="3254830"/>
                  <a:ext cx="2286000" cy="2286000"/>
                </a:xfrm>
                <a:prstGeom prst="rect">
                  <a:avLst/>
                </a:prstGeom>
              </p:spPr>
            </p:pic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0134CD44-2573-A359-8A9C-9517125F905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289184" y="3254829"/>
                  <a:ext cx="2286000" cy="2286000"/>
                </a:xfrm>
                <a:prstGeom prst="rect">
                  <a:avLst/>
                </a:prstGeom>
              </p:spPr>
            </p:pic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37B85EA1-DF59-D4BF-5AEF-D1BAB0DA860D}"/>
                    </a:ext>
                  </a:extLst>
                </p:cNvPr>
                <p:cNvSpPr txBox="1"/>
                <p:nvPr/>
              </p:nvSpPr>
              <p:spPr>
                <a:xfrm>
                  <a:off x="0" y="3254831"/>
                  <a:ext cx="3398367" cy="4001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350" dirty="0">
                      <a:solidFill>
                        <a:schemeClr val="bg1"/>
                      </a:solidFill>
                    </a:rPr>
                    <a:t>merged                               lipid  raft</a:t>
                  </a:r>
                </a:p>
              </p:txBody>
            </p:sp>
            <p:cxnSp>
              <p:nvCxnSpPr>
                <p:cNvPr id="15" name="Straight Connector 14">
                  <a:extLst>
                    <a:ext uri="{FF2B5EF4-FFF2-40B4-BE49-F238E27FC236}">
                      <a16:creationId xmlns:a16="http://schemas.microsoft.com/office/drawing/2014/main" id="{2A2F6D5E-BBCB-B9DF-F8B8-2CED6008A54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18288" y="3276602"/>
                  <a:ext cx="9144000" cy="16717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Straight Connector 15">
                  <a:extLst>
                    <a:ext uri="{FF2B5EF4-FFF2-40B4-BE49-F238E27FC236}">
                      <a16:creationId xmlns:a16="http://schemas.microsoft.com/office/drawing/2014/main" id="{3C3ADD5D-1125-CE86-6770-89E06DC00EA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276706" y="895677"/>
                  <a:ext cx="9294" cy="5243866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Connector 16">
                  <a:extLst>
                    <a:ext uri="{FF2B5EF4-FFF2-40B4-BE49-F238E27FC236}">
                      <a16:creationId xmlns:a16="http://schemas.microsoft.com/office/drawing/2014/main" id="{A85DF16F-69DD-DC13-C5A1-6F4EF4BAF7C9}"/>
                    </a:ext>
                  </a:extLst>
                </p:cNvPr>
                <p:cNvCxnSpPr/>
                <p:nvPr/>
              </p:nvCxnSpPr>
              <p:spPr>
                <a:xfrm flipH="1">
                  <a:off x="4572000" y="522514"/>
                  <a:ext cx="9294" cy="579120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5F319557-DB12-54D7-C3B3-858A686CEAFD}"/>
                  </a:ext>
                </a:extLst>
              </p:cNvPr>
              <p:cNvCxnSpPr/>
              <p:nvPr/>
            </p:nvCxnSpPr>
            <p:spPr>
              <a:xfrm>
                <a:off x="10982885" y="-381000"/>
                <a:ext cx="0" cy="434340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E5FAD7D3-F32C-1319-1116-8AAA4714566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284489" y="10886"/>
                <a:ext cx="1714500" cy="1714500"/>
              </a:xfrm>
              <a:prstGeom prst="rect">
                <a:avLst/>
              </a:prstGeom>
            </p:spPr>
          </p:pic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374E0A37-6FFD-7335-46C4-3EB2C8BEB4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998989" y="10886"/>
                <a:ext cx="1714500" cy="1714500"/>
              </a:xfrm>
              <a:prstGeom prst="rect">
                <a:avLst/>
              </a:prstGeom>
            </p:spPr>
          </p:pic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ABF72D6D-EAD2-6396-CE17-023E5F2D77D0}"/>
                  </a:ext>
                </a:extLst>
              </p:cNvPr>
              <p:cNvCxnSpPr/>
              <p:nvPr/>
            </p:nvCxnSpPr>
            <p:spPr>
              <a:xfrm>
                <a:off x="10998989" y="-103999"/>
                <a:ext cx="0" cy="2226564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CE595138-BA2D-3743-50AC-134C7871E46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264675" y="327468"/>
                <a:ext cx="6971" cy="393290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31FA416F-D2A2-E9CF-49F2-9567A9C2B7B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sharpenSoften amount="22000"/>
                        </a14:imgEffect>
                        <a14:imgEffect>
                          <a14:brightnessContrast bright="39000" contrast="29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030433" y="1754254"/>
                <a:ext cx="2179279" cy="2179279"/>
              </a:xfrm>
              <a:prstGeom prst="rect">
                <a:avLst/>
              </a:prstGeom>
            </p:spPr>
          </p:pic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8A63143-0E8A-F8AE-3091-0478DED0BBFD}"/>
                  </a:ext>
                </a:extLst>
              </p:cNvPr>
              <p:cNvSpPr txBox="1"/>
              <p:nvPr/>
            </p:nvSpPr>
            <p:spPr>
              <a:xfrm>
                <a:off x="5846131" y="27386"/>
                <a:ext cx="5628464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50" dirty="0">
                    <a:solidFill>
                      <a:schemeClr val="bg1"/>
                    </a:solidFill>
                  </a:rPr>
                  <a:t>CXCR4                                GM1                                   CXCR4                                 GM1</a:t>
                </a:r>
              </a:p>
            </p:txBody>
          </p:sp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3BB757BA-99EB-76FC-4C43-EAD6B521D909}"/>
                  </a:ext>
                </a:extLst>
              </p:cNvPr>
              <p:cNvCxnSpPr/>
              <p:nvPr/>
            </p:nvCxnSpPr>
            <p:spPr>
              <a:xfrm>
                <a:off x="9272953" y="1741716"/>
                <a:ext cx="757479" cy="2147206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id="{5235A136-D705-1A10-206C-C71B8A8CF3CA}"/>
                  </a:ext>
                </a:extLst>
              </p:cNvPr>
              <p:cNvCxnSpPr/>
              <p:nvPr/>
            </p:nvCxnSpPr>
            <p:spPr>
              <a:xfrm flipH="1">
                <a:off x="12209711" y="1747984"/>
                <a:ext cx="487675" cy="2185548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948DB3E8-A493-B47E-4870-386506A6A1B6}"/>
                  </a:ext>
                </a:extLst>
              </p:cNvPr>
              <p:cNvGrpSpPr/>
              <p:nvPr/>
            </p:nvGrpSpPr>
            <p:grpSpPr>
              <a:xfrm>
                <a:off x="5953685" y="-175748"/>
                <a:ext cx="3159578" cy="131771"/>
                <a:chOff x="152400" y="1264267"/>
                <a:chExt cx="4212770" cy="175695"/>
              </a:xfrm>
            </p:grpSpPr>
            <p:cxnSp>
              <p:nvCxnSpPr>
                <p:cNvPr id="28" name="Straight Connector 27">
                  <a:extLst>
                    <a:ext uri="{FF2B5EF4-FFF2-40B4-BE49-F238E27FC236}">
                      <a16:creationId xmlns:a16="http://schemas.microsoft.com/office/drawing/2014/main" id="{CFDE9F49-9F2B-702A-594F-49AE6967AE7A}"/>
                    </a:ext>
                  </a:extLst>
                </p:cNvPr>
                <p:cNvCxnSpPr/>
                <p:nvPr/>
              </p:nvCxnSpPr>
              <p:spPr>
                <a:xfrm>
                  <a:off x="163286" y="1359934"/>
                  <a:ext cx="4191000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Straight Connector 28">
                  <a:extLst>
                    <a:ext uri="{FF2B5EF4-FFF2-40B4-BE49-F238E27FC236}">
                      <a16:creationId xmlns:a16="http://schemas.microsoft.com/office/drawing/2014/main" id="{9959E6AF-9775-CBDB-3432-69F31B751214}"/>
                    </a:ext>
                  </a:extLst>
                </p:cNvPr>
                <p:cNvCxnSpPr/>
                <p:nvPr/>
              </p:nvCxnSpPr>
              <p:spPr>
                <a:xfrm>
                  <a:off x="152400" y="1264267"/>
                  <a:ext cx="0" cy="175695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Connector 29">
                  <a:extLst>
                    <a:ext uri="{FF2B5EF4-FFF2-40B4-BE49-F238E27FC236}">
                      <a16:creationId xmlns:a16="http://schemas.microsoft.com/office/drawing/2014/main" id="{E201F515-3A7B-AC9F-0C31-45D1A2AC5C4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365170" y="1264267"/>
                  <a:ext cx="0" cy="175695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id="{9911D102-1A13-1C82-14EB-DECF79D1E463}"/>
                  </a:ext>
                </a:extLst>
              </p:cNvPr>
              <p:cNvGrpSpPr/>
              <p:nvPr/>
            </p:nvGrpSpPr>
            <p:grpSpPr>
              <a:xfrm>
                <a:off x="9407181" y="-175751"/>
                <a:ext cx="3159578" cy="131771"/>
                <a:chOff x="152400" y="1264267"/>
                <a:chExt cx="4212770" cy="175695"/>
              </a:xfrm>
            </p:grpSpPr>
            <p:cxnSp>
              <p:nvCxnSpPr>
                <p:cNvPr id="32" name="Straight Connector 31">
                  <a:extLst>
                    <a:ext uri="{FF2B5EF4-FFF2-40B4-BE49-F238E27FC236}">
                      <a16:creationId xmlns:a16="http://schemas.microsoft.com/office/drawing/2014/main" id="{96FFAE4C-A2B9-A1A7-224A-A72B719547DE}"/>
                    </a:ext>
                  </a:extLst>
                </p:cNvPr>
                <p:cNvCxnSpPr/>
                <p:nvPr/>
              </p:nvCxnSpPr>
              <p:spPr>
                <a:xfrm>
                  <a:off x="163286" y="1359934"/>
                  <a:ext cx="4191000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Straight Connector 32">
                  <a:extLst>
                    <a:ext uri="{FF2B5EF4-FFF2-40B4-BE49-F238E27FC236}">
                      <a16:creationId xmlns:a16="http://schemas.microsoft.com/office/drawing/2014/main" id="{E760A816-ABBF-D006-749A-86126C86DB19}"/>
                    </a:ext>
                  </a:extLst>
                </p:cNvPr>
                <p:cNvCxnSpPr/>
                <p:nvPr/>
              </p:nvCxnSpPr>
              <p:spPr>
                <a:xfrm>
                  <a:off x="152400" y="1264267"/>
                  <a:ext cx="0" cy="175695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Straight Connector 33">
                  <a:extLst>
                    <a:ext uri="{FF2B5EF4-FFF2-40B4-BE49-F238E27FC236}">
                      <a16:creationId xmlns:a16="http://schemas.microsoft.com/office/drawing/2014/main" id="{AB272C64-7883-5A6A-4C29-A952BE93631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365170" y="1264267"/>
                  <a:ext cx="0" cy="175695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0622DF31-819D-3E5D-2569-17B4FC187EC8}"/>
                  </a:ext>
                </a:extLst>
              </p:cNvPr>
              <p:cNvSpPr txBox="1"/>
              <p:nvPr/>
            </p:nvSpPr>
            <p:spPr>
              <a:xfrm>
                <a:off x="7276301" y="-348809"/>
                <a:ext cx="556563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50" dirty="0">
                    <a:latin typeface="+mj-lt"/>
                  </a:rPr>
                  <a:t>PGE2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0AC36860-AA68-4FC2-13DA-F4F9BB7FC3BC}"/>
                  </a:ext>
                </a:extLst>
              </p:cNvPr>
              <p:cNvSpPr txBox="1"/>
              <p:nvPr/>
            </p:nvSpPr>
            <p:spPr>
              <a:xfrm>
                <a:off x="10500538" y="-369918"/>
                <a:ext cx="1023357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50" dirty="0">
                    <a:latin typeface="+mj-lt"/>
                  </a:rPr>
                  <a:t>PGE2 + NAC</a:t>
                </a:r>
              </a:p>
            </p:txBody>
          </p:sp>
        </p:grpSp>
        <p:sp>
          <p:nvSpPr>
            <p:cNvPr id="8" name="TextBox 46">
              <a:extLst>
                <a:ext uri="{FF2B5EF4-FFF2-40B4-BE49-F238E27FC236}">
                  <a16:creationId xmlns:a16="http://schemas.microsoft.com/office/drawing/2014/main" id="{4A6D0CA5-2F2D-86B6-07EC-0084FBD33892}"/>
                </a:ext>
              </a:extLst>
            </p:cNvPr>
            <p:cNvSpPr txBox="1"/>
            <p:nvPr/>
          </p:nvSpPr>
          <p:spPr>
            <a:xfrm>
              <a:off x="5144266" y="433521"/>
              <a:ext cx="32893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2000" b="1" dirty="0"/>
                <a:t>B</a:t>
              </a:r>
            </a:p>
          </p:txBody>
        </p:sp>
        <p:sp>
          <p:nvSpPr>
            <p:cNvPr id="48" name="pole tekstowe 47">
              <a:extLst>
                <a:ext uri="{FF2B5EF4-FFF2-40B4-BE49-F238E27FC236}">
                  <a16:creationId xmlns:a16="http://schemas.microsoft.com/office/drawing/2014/main" id="{7DD732C8-C0AF-B51B-3CEF-EAAFE85E40C1}"/>
                </a:ext>
              </a:extLst>
            </p:cNvPr>
            <p:cNvSpPr txBox="1"/>
            <p:nvPr/>
          </p:nvSpPr>
          <p:spPr>
            <a:xfrm>
              <a:off x="9853352" y="5178514"/>
              <a:ext cx="12958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u="sng" dirty="0">
                  <a:solidFill>
                    <a:srgbClr val="FF0000"/>
                  </a:solidFill>
                </a:rPr>
                <a:t>No lipid </a:t>
              </a:r>
              <a:r>
                <a:rPr lang="pl-PL" u="sng" dirty="0" err="1">
                  <a:solidFill>
                    <a:srgbClr val="FF0000"/>
                  </a:solidFill>
                </a:rPr>
                <a:t>raft</a:t>
              </a:r>
              <a:endParaRPr lang="pl-PL" u="sng" dirty="0">
                <a:solidFill>
                  <a:srgbClr val="FF0000"/>
                </a:solidFill>
              </a:endParaRP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527D4951-DAF1-E128-8A73-18F6895D557F}"/>
                </a:ext>
              </a:extLst>
            </p:cNvPr>
            <p:cNvSpPr/>
            <p:nvPr/>
          </p:nvSpPr>
          <p:spPr>
            <a:xfrm>
              <a:off x="5158575" y="471696"/>
              <a:ext cx="7028237" cy="582398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</p:spTree>
    <p:extLst>
      <p:ext uri="{BB962C8B-B14F-4D97-AF65-F5344CB8AC3E}">
        <p14:creationId xmlns:p14="http://schemas.microsoft.com/office/powerpoint/2010/main" val="20313557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24</TotalTime>
  <Words>25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mila Bujko</dc:creator>
  <cp:lastModifiedBy>Mariusz Ratajczak</cp:lastModifiedBy>
  <cp:revision>120</cp:revision>
  <cp:lastPrinted>2024-05-21T08:30:26Z</cp:lastPrinted>
  <dcterms:created xsi:type="dcterms:W3CDTF">2024-01-09T10:53:16Z</dcterms:created>
  <dcterms:modified xsi:type="dcterms:W3CDTF">2024-07-17T16:01:03Z</dcterms:modified>
</cp:coreProperties>
</file>